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81" d="100"/>
          <a:sy n="81" d="100"/>
        </p:scale>
        <p:origin x="309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E4415-2702-4A0C-A773-FDB5C925ABC1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C38AA2-5100-45B7-81E5-57358682BA99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0614644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E4415-2702-4A0C-A773-FDB5C925ABC1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C38AA2-5100-45B7-81E5-57358682BA99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3462620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E4415-2702-4A0C-A773-FDB5C925ABC1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C38AA2-5100-45B7-81E5-57358682BA99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7508779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E4415-2702-4A0C-A773-FDB5C925ABC1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C38AA2-5100-45B7-81E5-57358682BA99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7903246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E4415-2702-4A0C-A773-FDB5C925ABC1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C38AA2-5100-45B7-81E5-57358682BA99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0206933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E4415-2702-4A0C-A773-FDB5C925ABC1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C38AA2-5100-45B7-81E5-57358682BA99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3185126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E4415-2702-4A0C-A773-FDB5C925ABC1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C38AA2-5100-45B7-81E5-57358682BA99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2347679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E4415-2702-4A0C-A773-FDB5C925ABC1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C38AA2-5100-45B7-81E5-57358682BA99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495061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E4415-2702-4A0C-A773-FDB5C925ABC1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C38AA2-5100-45B7-81E5-57358682BA99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8339615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E4415-2702-4A0C-A773-FDB5C925ABC1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C38AA2-5100-45B7-81E5-57358682BA99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6897893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E4415-2702-4A0C-A773-FDB5C925ABC1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C38AA2-5100-45B7-81E5-57358682BA99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5663946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CE4415-2702-4A0C-A773-FDB5C925ABC1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C38AA2-5100-45B7-81E5-57358682BA99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5116125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533671664"/>
              </p:ext>
            </p:extLst>
          </p:nvPr>
        </p:nvGraphicFramePr>
        <p:xfrm>
          <a:off x="264380" y="410370"/>
          <a:ext cx="5307965" cy="2138172"/>
        </p:xfrm>
        <a:graphic>
          <a:graphicData uri="http://schemas.openxmlformats.org/drawingml/2006/table">
            <a:tbl>
              <a:tblPr firstRow="1" firstCol="1" bandRow="1">
                <a:tableStyleId>{7E9639D4-E3E2-4D34-9284-5A2195B3D0D7}</a:tableStyleId>
              </a:tblPr>
              <a:tblGrid>
                <a:gridCol w="1437005">
                  <a:extLst>
                    <a:ext uri="{9D8B030D-6E8A-4147-A177-3AD203B41FA5}">
                      <a16:colId xmlns:a16="http://schemas.microsoft.com/office/drawing/2014/main" val="618897037"/>
                    </a:ext>
                  </a:extLst>
                </a:gridCol>
                <a:gridCol w="3870960">
                  <a:extLst>
                    <a:ext uri="{9D8B030D-6E8A-4147-A177-3AD203B41FA5}">
                      <a16:colId xmlns:a16="http://schemas.microsoft.com/office/drawing/2014/main" val="359199747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kern="1200">
                          <a:solidFill>
                            <a:sysClr val="windowText" lastClr="000000"/>
                          </a:solidFill>
                          <a:effectLst/>
                        </a:rPr>
                        <a:t>miRNA</a:t>
                      </a:r>
                      <a:endParaRPr lang="en-GB" sz="11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kern="1200" dirty="0">
                          <a:solidFill>
                            <a:sysClr val="windowText" lastClr="000000"/>
                          </a:solidFill>
                          <a:effectLst/>
                        </a:rPr>
                        <a:t>The predicted target mRNA that match DEGs in transcriptome</a:t>
                      </a:r>
                      <a:endParaRPr lang="en-GB" sz="110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904892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kern="1200">
                          <a:effectLst/>
                        </a:rPr>
                        <a:t>mR-200b-3p </a:t>
                      </a:r>
                      <a:r>
                        <a:rPr lang="en-GB" sz="1400" kern="1200">
                          <a:effectLst/>
                        </a:rPr>
                        <a:t>↓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400" kern="1200">
                          <a:effectLst/>
                        </a:rPr>
                        <a:t>↑</a:t>
                      </a:r>
                      <a:r>
                        <a:rPr lang="en-GB" sz="1200" kern="1200">
                          <a:effectLst/>
                        </a:rPr>
                        <a:t> Cldn11, Ugt8a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17150572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kern="1200">
                          <a:effectLst/>
                        </a:rPr>
                        <a:t>miR-200c-3p </a:t>
                      </a:r>
                      <a:r>
                        <a:rPr lang="en-GB" sz="1400" kern="1200">
                          <a:effectLst/>
                        </a:rPr>
                        <a:t>↓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400" kern="1200">
                          <a:effectLst/>
                        </a:rPr>
                        <a:t>↑</a:t>
                      </a:r>
                      <a:r>
                        <a:rPr lang="en-GB" sz="1200" kern="1200">
                          <a:effectLst/>
                        </a:rPr>
                        <a:t> Cldn11, Ugt8a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938327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kern="1200">
                          <a:effectLst/>
                        </a:rPr>
                        <a:t>miR-429-3p </a:t>
                      </a:r>
                      <a:r>
                        <a:rPr lang="en-GB" sz="1400" kern="1200">
                          <a:effectLst/>
                        </a:rPr>
                        <a:t>↓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400" kern="1200">
                          <a:effectLst/>
                        </a:rPr>
                        <a:t>↑</a:t>
                      </a:r>
                      <a:r>
                        <a:rPr lang="en-GB" sz="1200" kern="1200">
                          <a:effectLst/>
                        </a:rPr>
                        <a:t> Cldn11, Ugt8a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70567082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kern="1200">
                          <a:effectLst/>
                        </a:rPr>
                        <a:t>miR-183-5p </a:t>
                      </a:r>
                      <a:r>
                        <a:rPr lang="en-GB" sz="1400" kern="1200">
                          <a:effectLst/>
                        </a:rPr>
                        <a:t>↓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400" kern="1200">
                          <a:effectLst/>
                        </a:rPr>
                        <a:t>↑ </a:t>
                      </a:r>
                      <a:r>
                        <a:rPr lang="en-GB" sz="1200" kern="1200">
                          <a:effectLst/>
                        </a:rPr>
                        <a:t>Mbp, Tspan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40190509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kern="1200">
                          <a:effectLst/>
                        </a:rPr>
                        <a:t>miR-10b-5p </a:t>
                      </a:r>
                      <a:r>
                        <a:rPr lang="en-GB" sz="1400" kern="1200">
                          <a:effectLst/>
                        </a:rPr>
                        <a:t>↓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400" kern="1200">
                          <a:effectLst/>
                        </a:rPr>
                        <a:t>↑</a:t>
                      </a:r>
                      <a:r>
                        <a:rPr lang="en-GB" sz="1200" kern="1200">
                          <a:effectLst/>
                        </a:rPr>
                        <a:t> Mbp, Gjc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89451683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kern="1200">
                          <a:effectLst/>
                        </a:rPr>
                        <a:t>miR-200a-3p </a:t>
                      </a:r>
                      <a:r>
                        <a:rPr lang="en-GB" sz="1400" kern="1200">
                          <a:effectLst/>
                        </a:rPr>
                        <a:t>↓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400" kern="1200">
                          <a:effectLst/>
                        </a:rPr>
                        <a:t>↑</a:t>
                      </a:r>
                      <a:r>
                        <a:rPr lang="en-GB" sz="1200" kern="1200">
                          <a:effectLst/>
                        </a:rPr>
                        <a:t> Gjc3, Plp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75867747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kern="1200">
                          <a:effectLst/>
                        </a:rPr>
                        <a:t>miR-182-5p </a:t>
                      </a:r>
                      <a:r>
                        <a:rPr lang="en-GB" sz="1400" kern="1200">
                          <a:effectLst/>
                        </a:rPr>
                        <a:t>↓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400" kern="1200" dirty="0">
                          <a:effectLst/>
                        </a:rPr>
                        <a:t>↑ </a:t>
                      </a:r>
                      <a:r>
                        <a:rPr lang="en-GB" sz="1200" kern="1200" dirty="0">
                          <a:effectLst/>
                        </a:rPr>
                        <a:t>Mag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756364687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169376" y="133371"/>
            <a:ext cx="32507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Supplemental Table 5.</a:t>
            </a:r>
            <a:endParaRPr lang="en-GB" sz="1200" b="1" dirty="0"/>
          </a:p>
        </p:txBody>
      </p:sp>
    </p:spTree>
    <p:extLst>
      <p:ext uri="{BB962C8B-B14F-4D97-AF65-F5344CB8AC3E}">
        <p14:creationId xmlns:p14="http://schemas.microsoft.com/office/powerpoint/2010/main" val="41670773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</TotalTime>
  <Words>54</Words>
  <Application>Microsoft Office PowerPoint</Application>
  <PresentationFormat>A4 Paper (210x297 mm)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Hewlett-Packar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n</dc:creator>
  <cp:lastModifiedBy>Hoban, Alan</cp:lastModifiedBy>
  <cp:revision>6</cp:revision>
  <dcterms:created xsi:type="dcterms:W3CDTF">2016-09-14T11:07:02Z</dcterms:created>
  <dcterms:modified xsi:type="dcterms:W3CDTF">2017-01-14T13:09:01Z</dcterms:modified>
</cp:coreProperties>
</file>